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65547" y="1900246"/>
              <a:ext cx="4865663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65547" y="5498904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65547" y="4739883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65547" y="3980862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65547" y="3221841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465547" y="2462820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09883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322776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435669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548563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65547" y="5878414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465547" y="5119393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465547" y="4360372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465547" y="3601352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465547" y="2842331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465547" y="2083310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53436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66329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379223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492116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605009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729218" y="4225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729218" y="4225351"/>
              <a:ext cx="0" cy="148919"/>
            </a:xfrm>
            <a:custGeom>
              <a:avLst/>
              <a:pathLst>
                <a:path w="0" h="148919">
                  <a:moveTo>
                    <a:pt x="0" y="0"/>
                  </a:moveTo>
                  <a:lnTo>
                    <a:pt x="0" y="1489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729218" y="43742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997848" y="4057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997848" y="4057917"/>
              <a:ext cx="0" cy="323363"/>
            </a:xfrm>
            <a:custGeom>
              <a:avLst/>
              <a:pathLst>
                <a:path w="0" h="323363">
                  <a:moveTo>
                    <a:pt x="0" y="0"/>
                  </a:moveTo>
                  <a:lnTo>
                    <a:pt x="0" y="3233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997848" y="43812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827887" y="44514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827887" y="4451459"/>
              <a:ext cx="0" cy="212137"/>
            </a:xfrm>
            <a:custGeom>
              <a:avLst/>
              <a:pathLst>
                <a:path w="0" h="212137">
                  <a:moveTo>
                    <a:pt x="0" y="0"/>
                  </a:moveTo>
                  <a:lnTo>
                    <a:pt x="0" y="2121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827887" y="4663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962682" y="4273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962682" y="4273580"/>
              <a:ext cx="0" cy="287067"/>
            </a:xfrm>
            <a:custGeom>
              <a:avLst/>
              <a:pathLst>
                <a:path w="0" h="287067">
                  <a:moveTo>
                    <a:pt x="0" y="0"/>
                  </a:moveTo>
                  <a:lnTo>
                    <a:pt x="0" y="2870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962682" y="45606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322669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5322669" y="2086637"/>
              <a:ext cx="0" cy="1759586"/>
            </a:xfrm>
            <a:custGeom>
              <a:avLst/>
              <a:pathLst>
                <a:path w="0" h="1759586">
                  <a:moveTo>
                    <a:pt x="0" y="0"/>
                  </a:moveTo>
                  <a:lnTo>
                    <a:pt x="0" y="17595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5322669" y="38462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43466" y="43548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43466" y="4354877"/>
              <a:ext cx="0" cy="230280"/>
            </a:xfrm>
            <a:custGeom>
              <a:avLst/>
              <a:pathLst>
                <a:path w="0" h="230280">
                  <a:moveTo>
                    <a:pt x="0" y="0"/>
                  </a:moveTo>
                  <a:lnTo>
                    <a:pt x="0" y="2302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843466" y="4585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124740" y="42140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124740" y="4214035"/>
              <a:ext cx="0" cy="384473"/>
            </a:xfrm>
            <a:custGeom>
              <a:avLst/>
              <a:pathLst>
                <a:path w="0" h="384473">
                  <a:moveTo>
                    <a:pt x="0" y="0"/>
                  </a:moveTo>
                  <a:lnTo>
                    <a:pt x="0" y="3844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124740" y="45985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4307645" y="42236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4307645" y="4223603"/>
              <a:ext cx="0" cy="1590871"/>
            </a:xfrm>
            <a:custGeom>
              <a:avLst/>
              <a:pathLst>
                <a:path w="0" h="1590871">
                  <a:moveTo>
                    <a:pt x="0" y="0"/>
                  </a:moveTo>
                  <a:lnTo>
                    <a:pt x="0" y="15908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307645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764667" y="43273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764667" y="4327358"/>
              <a:ext cx="0" cy="160357"/>
            </a:xfrm>
            <a:custGeom>
              <a:avLst/>
              <a:pathLst>
                <a:path w="0" h="160357">
                  <a:moveTo>
                    <a:pt x="0" y="0"/>
                  </a:moveTo>
                  <a:lnTo>
                    <a:pt x="0" y="1603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764667" y="4487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771722" y="42998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686714" y="4299811"/>
              <a:ext cx="85008" cy="0"/>
            </a:xfrm>
            <a:custGeom>
              <a:avLst/>
              <a:pathLst>
                <a:path w="85008" h="0">
                  <a:moveTo>
                    <a:pt x="8500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686714" y="42998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097363" y="421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898332" y="4219598"/>
              <a:ext cx="199030" cy="0"/>
            </a:xfrm>
            <a:custGeom>
              <a:avLst/>
              <a:pathLst>
                <a:path w="199030" h="0">
                  <a:moveTo>
                    <a:pt x="1990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898332" y="421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889752" y="4557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766021" y="4557527"/>
              <a:ext cx="123731" cy="0"/>
            </a:xfrm>
            <a:custGeom>
              <a:avLst/>
              <a:pathLst>
                <a:path w="123731" h="0">
                  <a:moveTo>
                    <a:pt x="1237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766021" y="4557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049722" y="4417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875641" y="4417114"/>
              <a:ext cx="174081" cy="0"/>
            </a:xfrm>
            <a:custGeom>
              <a:avLst/>
              <a:pathLst>
                <a:path w="174081" h="0">
                  <a:moveTo>
                    <a:pt x="1740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875641" y="4417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6110044" y="2966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4535295" y="2966431"/>
              <a:ext cx="1574749" cy="0"/>
            </a:xfrm>
            <a:custGeom>
              <a:avLst/>
              <a:pathLst>
                <a:path w="1574749" h="0">
                  <a:moveTo>
                    <a:pt x="15747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4535295" y="2966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911033" y="4470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775900" y="4470018"/>
              <a:ext cx="135133" cy="0"/>
            </a:xfrm>
            <a:custGeom>
              <a:avLst/>
              <a:pathLst>
                <a:path w="135133" h="0">
                  <a:moveTo>
                    <a:pt x="1351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775900" y="4470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242939" y="4406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006541" y="4406272"/>
              <a:ext cx="236398" cy="0"/>
            </a:xfrm>
            <a:custGeom>
              <a:avLst/>
              <a:pathLst>
                <a:path w="236398" h="0">
                  <a:moveTo>
                    <a:pt x="2363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006541" y="4406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4914447" y="50190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3700844" y="5019039"/>
              <a:ext cx="1213603" cy="0"/>
            </a:xfrm>
            <a:custGeom>
              <a:avLst/>
              <a:pathLst>
                <a:path w="1213603" h="0">
                  <a:moveTo>
                    <a:pt x="12136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3700844" y="50190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10840" y="4407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718493" y="4407537"/>
              <a:ext cx="92346" cy="0"/>
            </a:xfrm>
            <a:custGeom>
              <a:avLst/>
              <a:pathLst>
                <a:path w="92346" h="0">
                  <a:moveTo>
                    <a:pt x="923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718493" y="4407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1704392" y="42749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1"/>
            <p:cNvSpPr/>
            <p:nvPr/>
          </p:nvSpPr>
          <p:spPr>
            <a:xfrm>
              <a:off x="1973022" y="41947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2"/>
            <p:cNvSpPr/>
            <p:nvPr/>
          </p:nvSpPr>
          <p:spPr>
            <a:xfrm>
              <a:off x="1803061" y="45327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3"/>
            <p:cNvSpPr/>
            <p:nvPr/>
          </p:nvSpPr>
          <p:spPr>
            <a:xfrm>
              <a:off x="1937856" y="43922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t84"/>
            <p:cNvSpPr/>
            <p:nvPr/>
          </p:nvSpPr>
          <p:spPr>
            <a:xfrm>
              <a:off x="5297843" y="29416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t85"/>
            <p:cNvSpPr/>
            <p:nvPr/>
          </p:nvSpPr>
          <p:spPr>
            <a:xfrm>
              <a:off x="1818640" y="44451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6"/>
            <p:cNvSpPr/>
            <p:nvPr/>
          </p:nvSpPr>
          <p:spPr>
            <a:xfrm>
              <a:off x="2099914" y="43814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t87"/>
            <p:cNvSpPr/>
            <p:nvPr/>
          </p:nvSpPr>
          <p:spPr>
            <a:xfrm>
              <a:off x="4282819" y="49942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t88"/>
            <p:cNvSpPr/>
            <p:nvPr/>
          </p:nvSpPr>
          <p:spPr>
            <a:xfrm>
              <a:off x="1739841" y="43827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465547" y="4358208"/>
              <a:ext cx="4865663" cy="153037"/>
            </a:xfrm>
            <a:custGeom>
              <a:avLst/>
              <a:pathLst>
                <a:path w="4865663" h="153037">
                  <a:moveTo>
                    <a:pt x="0" y="0"/>
                  </a:moveTo>
                  <a:lnTo>
                    <a:pt x="4865663" y="153037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465547" y="3940386"/>
              <a:ext cx="4865663" cy="489445"/>
            </a:xfrm>
            <a:custGeom>
              <a:avLst/>
              <a:pathLst>
                <a:path w="4865663" h="489445">
                  <a:moveTo>
                    <a:pt x="0" y="489445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465547" y="4352754"/>
              <a:ext cx="4865663" cy="538643"/>
            </a:xfrm>
            <a:custGeom>
              <a:avLst/>
              <a:pathLst>
                <a:path w="4865663" h="538643">
                  <a:moveTo>
                    <a:pt x="0" y="0"/>
                  </a:moveTo>
                  <a:lnTo>
                    <a:pt x="4865663" y="538643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465547" y="4347714"/>
              <a:ext cx="4865663" cy="895040"/>
            </a:xfrm>
            <a:custGeom>
              <a:avLst/>
              <a:pathLst>
                <a:path w="4865663" h="895040">
                  <a:moveTo>
                    <a:pt x="0" y="0"/>
                  </a:moveTo>
                  <a:lnTo>
                    <a:pt x="4865663" y="89504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tx93"/>
            <p:cNvSpPr/>
            <p:nvPr/>
          </p:nvSpPr>
          <p:spPr>
            <a:xfrm>
              <a:off x="1148183" y="5836722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50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1148183" y="5077702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5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1185400" y="4318681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1185400" y="3559660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1185400" y="2800639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1185400" y="2041618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100" name="pl99"/>
            <p:cNvSpPr/>
            <p:nvPr/>
          </p:nvSpPr>
          <p:spPr>
            <a:xfrm>
              <a:off x="1430753" y="58784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430753" y="51193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430753" y="43603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430753" y="36013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430753" y="28423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430753" y="20833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53436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66329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3792231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492116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605009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tx110"/>
            <p:cNvSpPr/>
            <p:nvPr/>
          </p:nvSpPr>
          <p:spPr>
            <a:xfrm>
              <a:off x="1503286" y="6061805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12" name="tx111"/>
            <p:cNvSpPr/>
            <p:nvPr/>
          </p:nvSpPr>
          <p:spPr>
            <a:xfrm>
              <a:off x="2632220" y="6063169"/>
              <a:ext cx="62155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13" name="tx112"/>
            <p:cNvSpPr/>
            <p:nvPr/>
          </p:nvSpPr>
          <p:spPr>
            <a:xfrm>
              <a:off x="3761153" y="6063496"/>
              <a:ext cx="62155" cy="8000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14" name="tx113"/>
            <p:cNvSpPr/>
            <p:nvPr/>
          </p:nvSpPr>
          <p:spPr>
            <a:xfrm>
              <a:off x="4890086" y="6061805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115" name="tx114"/>
            <p:cNvSpPr/>
            <p:nvPr/>
          </p:nvSpPr>
          <p:spPr>
            <a:xfrm>
              <a:off x="6019020" y="6061805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16" name="tx115"/>
            <p:cNvSpPr/>
            <p:nvPr/>
          </p:nvSpPr>
          <p:spPr>
            <a:xfrm>
              <a:off x="1928834" y="6170637"/>
              <a:ext cx="3939089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Hyperhidrosis || id:finn-b-R18_HYPERHIDROSIS</a:t>
              </a:r>
            </a:p>
          </p:txBody>
        </p:sp>
        <p:sp>
          <p:nvSpPr>
            <p:cNvPr id="117" name="tx116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118" name="rc117"/>
            <p:cNvSpPr/>
            <p:nvPr/>
          </p:nvSpPr>
          <p:spPr>
            <a:xfrm>
              <a:off x="2420884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9" name="tx118"/>
            <p:cNvSpPr/>
            <p:nvPr/>
          </p:nvSpPr>
          <p:spPr>
            <a:xfrm>
              <a:off x="2490473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120" name="rc119"/>
            <p:cNvSpPr/>
            <p:nvPr/>
          </p:nvSpPr>
          <p:spPr>
            <a:xfrm>
              <a:off x="2490473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490473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rc121"/>
            <p:cNvSpPr/>
            <p:nvPr/>
          </p:nvSpPr>
          <p:spPr>
            <a:xfrm>
              <a:off x="2490473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490473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rc123"/>
            <p:cNvSpPr/>
            <p:nvPr/>
          </p:nvSpPr>
          <p:spPr>
            <a:xfrm>
              <a:off x="4147498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4147498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rc125"/>
            <p:cNvSpPr/>
            <p:nvPr/>
          </p:nvSpPr>
          <p:spPr>
            <a:xfrm>
              <a:off x="4147498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147498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tx127"/>
            <p:cNvSpPr/>
            <p:nvPr/>
          </p:nvSpPr>
          <p:spPr>
            <a:xfrm>
              <a:off x="2779518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129" name="tx128"/>
            <p:cNvSpPr/>
            <p:nvPr/>
          </p:nvSpPr>
          <p:spPr>
            <a:xfrm>
              <a:off x="2779518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30" name="tx129"/>
            <p:cNvSpPr/>
            <p:nvPr/>
          </p:nvSpPr>
          <p:spPr>
            <a:xfrm>
              <a:off x="4436543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31" name="tx130"/>
            <p:cNvSpPr/>
            <p:nvPr/>
          </p:nvSpPr>
          <p:spPr>
            <a:xfrm>
              <a:off x="4436543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2:36:48Z</dcterms:modified>
  <cp:category/>
</cp:coreProperties>
</file>